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257" r:id="rId2"/>
    <p:sldId id="258" r:id="rId3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71" autoAdjust="0"/>
    <p:restoredTop sz="93651" autoAdjust="0"/>
  </p:normalViewPr>
  <p:slideViewPr>
    <p:cSldViewPr snapToGrid="0" snapToObjects="1">
      <p:cViewPr>
        <p:scale>
          <a:sx n="100" d="100"/>
          <a:sy n="100" d="100"/>
        </p:scale>
        <p:origin x="-318" y="-13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03A772-243E-6248-AA02-A5DC1C468BF3}" type="datetimeFigureOut">
              <a:rPr lang="en-US" smtClean="0"/>
              <a:t>7/8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981C68F-F416-694C-AC38-36DBE40487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3527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 smtClean="0"/>
              <a:t>[Consider changing “count” to </a:t>
            </a:r>
            <a:r>
              <a:rPr lang="en-US" b="1" smtClean="0"/>
              <a:t>“counts”.]</a:t>
            </a:r>
            <a:endParaRPr lang="en-US" b="1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981C68F-F416-694C-AC38-36DBE404874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05761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0C3C7-3F36-E845-82FA-9683A0FE8C47}" type="datetimeFigureOut">
              <a:rPr kumimoji="1" lang="ja-JP" altLang="en-US" smtClean="0"/>
              <a:t>2019/7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1B5B8-2746-8049-9BC1-D777DA28EB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8225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0C3C7-3F36-E845-82FA-9683A0FE8C47}" type="datetimeFigureOut">
              <a:rPr kumimoji="1" lang="ja-JP" altLang="en-US" smtClean="0"/>
              <a:t>2019/7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1B5B8-2746-8049-9BC1-D777DA28EB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92390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0C3C7-3F36-E845-82FA-9683A0FE8C47}" type="datetimeFigureOut">
              <a:rPr kumimoji="1" lang="ja-JP" altLang="en-US" smtClean="0"/>
              <a:t>2019/7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1B5B8-2746-8049-9BC1-D777DA28EB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9361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0C3C7-3F36-E845-82FA-9683A0FE8C47}" type="datetimeFigureOut">
              <a:rPr kumimoji="1" lang="ja-JP" altLang="en-US" smtClean="0"/>
              <a:t>2019/7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1B5B8-2746-8049-9BC1-D777DA28EB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84467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0C3C7-3F36-E845-82FA-9683A0FE8C47}" type="datetimeFigureOut">
              <a:rPr kumimoji="1" lang="ja-JP" altLang="en-US" smtClean="0"/>
              <a:t>2019/7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1B5B8-2746-8049-9BC1-D777DA28EB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34810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0C3C7-3F36-E845-82FA-9683A0FE8C47}" type="datetimeFigureOut">
              <a:rPr kumimoji="1" lang="ja-JP" altLang="en-US" smtClean="0"/>
              <a:t>2019/7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1B5B8-2746-8049-9BC1-D777DA28EB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75835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0C3C7-3F36-E845-82FA-9683A0FE8C47}" type="datetimeFigureOut">
              <a:rPr kumimoji="1" lang="ja-JP" altLang="en-US" smtClean="0"/>
              <a:t>2019/7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1B5B8-2746-8049-9BC1-D777DA28EB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70402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0C3C7-3F36-E845-82FA-9683A0FE8C47}" type="datetimeFigureOut">
              <a:rPr kumimoji="1" lang="ja-JP" altLang="en-US" smtClean="0"/>
              <a:t>2019/7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1B5B8-2746-8049-9BC1-D777DA28EB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18929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0C3C7-3F36-E845-82FA-9683A0FE8C47}" type="datetimeFigureOut">
              <a:rPr kumimoji="1" lang="ja-JP" altLang="en-US" smtClean="0"/>
              <a:t>2019/7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1B5B8-2746-8049-9BC1-D777DA28EB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7229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0C3C7-3F36-E845-82FA-9683A0FE8C47}" type="datetimeFigureOut">
              <a:rPr kumimoji="1" lang="ja-JP" altLang="en-US" smtClean="0"/>
              <a:t>2019/7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1B5B8-2746-8049-9BC1-D777DA28EB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14960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0C3C7-3F36-E845-82FA-9683A0FE8C47}" type="datetimeFigureOut">
              <a:rPr kumimoji="1" lang="ja-JP" altLang="en-US" smtClean="0"/>
              <a:t>2019/7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1B5B8-2746-8049-9BC1-D777DA28EB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2543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A0C3C7-3F36-E845-82FA-9683A0FE8C47}" type="datetimeFigureOut">
              <a:rPr kumimoji="1" lang="ja-JP" altLang="en-US" smtClean="0"/>
              <a:t>2019/7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81B5B8-2746-8049-9BC1-D777DA28EB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26874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tiff"/><Relationship Id="rId5" Type="http://schemas.openxmlformats.org/officeDocument/2006/relationships/image" Target="../media/image9.tiff"/><Relationship Id="rId4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="" xmlns:a16="http://schemas.microsoft.com/office/drawing/2014/main" id="{73AFAD61-20A2-B442-AAB7-B727BDFA35D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6635" y="2171744"/>
            <a:ext cx="2227426" cy="2119101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="" xmlns:a16="http://schemas.microsoft.com/office/drawing/2014/main" id="{8E79967B-62C7-2C45-8DE3-EB2B62866F4B}"/>
              </a:ext>
            </a:extLst>
          </p:cNvPr>
          <p:cNvSpPr txBox="1"/>
          <p:nvPr/>
        </p:nvSpPr>
        <p:spPr>
          <a:xfrm>
            <a:off x="746860" y="1688960"/>
            <a:ext cx="1631539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 smtClean="0">
                <a:latin typeface="Helvetica" pitchFamily="2" charset="0"/>
              </a:rPr>
              <a:t>Lymphocyte </a:t>
            </a:r>
            <a:r>
              <a:rPr lang="en-US" altLang="ja-JP" sz="1350" dirty="0">
                <a:latin typeface="Helvetica" pitchFamily="2" charset="0"/>
              </a:rPr>
              <a:t>gating</a:t>
            </a:r>
            <a:endParaRPr lang="ja-JP" altLang="en-US" sz="1350" dirty="0">
              <a:latin typeface="Helvetica" pitchFamily="2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="" xmlns:a16="http://schemas.microsoft.com/office/drawing/2014/main" id="{D2CEAE3D-9B6E-AF49-AE31-0C0D2112AA31}"/>
              </a:ext>
            </a:extLst>
          </p:cNvPr>
          <p:cNvSpPr txBox="1"/>
          <p:nvPr/>
        </p:nvSpPr>
        <p:spPr>
          <a:xfrm>
            <a:off x="5627949" y="587086"/>
            <a:ext cx="81976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 smtClean="0">
                <a:latin typeface="Helvetica" pitchFamily="2" charset="0"/>
              </a:rPr>
              <a:t>8 weeks</a:t>
            </a:r>
            <a:endParaRPr lang="ja-JP" altLang="en-US" sz="1350" dirty="0">
              <a:latin typeface="Helvetica" pitchFamily="2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="" xmlns:a16="http://schemas.microsoft.com/office/drawing/2014/main" id="{C8172703-68D5-CB41-87BD-C8AB02B02A7E}"/>
              </a:ext>
            </a:extLst>
          </p:cNvPr>
          <p:cNvSpPr txBox="1"/>
          <p:nvPr/>
        </p:nvSpPr>
        <p:spPr>
          <a:xfrm>
            <a:off x="5579859" y="3714877"/>
            <a:ext cx="916049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 smtClean="0">
                <a:latin typeface="Helvetica" pitchFamily="2" charset="0"/>
              </a:rPr>
              <a:t>48 weeks</a:t>
            </a:r>
            <a:endParaRPr lang="ja-JP" altLang="en-US" sz="1350" dirty="0">
              <a:latin typeface="Helvetica" pitchFamily="2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="" xmlns:a16="http://schemas.microsoft.com/office/drawing/2014/main" id="{F859EB12-1508-F14A-A954-7B911508BA8C}"/>
              </a:ext>
            </a:extLst>
          </p:cNvPr>
          <p:cNvSpPr txBox="1"/>
          <p:nvPr/>
        </p:nvSpPr>
        <p:spPr>
          <a:xfrm>
            <a:off x="193511" y="395864"/>
            <a:ext cx="61747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Helvetica" pitchFamily="2" charset="0"/>
              </a:rPr>
              <a:t>SLGs</a:t>
            </a:r>
            <a:endParaRPr lang="ja-JP" altLang="en-US" sz="1350">
              <a:latin typeface="Helvetica" pitchFamily="2" charset="0"/>
            </a:endParaRPr>
          </a:p>
        </p:txBody>
      </p:sp>
      <p:pic>
        <p:nvPicPr>
          <p:cNvPr id="18" name="図 17">
            <a:extLst>
              <a:ext uri="{FF2B5EF4-FFF2-40B4-BE49-F238E27FC236}">
                <a16:creationId xmlns="" xmlns:a16="http://schemas.microsoft.com/office/drawing/2014/main" id="{93F3BEE1-8F29-4446-80A5-599F881A129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69876" y="1206580"/>
            <a:ext cx="2049609" cy="1950300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="" xmlns:a16="http://schemas.microsoft.com/office/drawing/2014/main" id="{4429D6AE-D6CE-C844-BE50-E7FF580D671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15447" y="4298603"/>
            <a:ext cx="2049609" cy="1938120"/>
          </a:xfrm>
          <a:prstGeom prst="rect">
            <a:avLst/>
          </a:prstGeom>
        </p:spPr>
      </p:pic>
      <p:sp>
        <p:nvSpPr>
          <p:cNvPr id="20" name="テキスト ボックス 19">
            <a:extLst>
              <a:ext uri="{FF2B5EF4-FFF2-40B4-BE49-F238E27FC236}">
                <a16:creationId xmlns="" xmlns:a16="http://schemas.microsoft.com/office/drawing/2014/main" id="{0D05F618-7BFF-0B40-BE04-0E768EFD583D}"/>
              </a:ext>
            </a:extLst>
          </p:cNvPr>
          <p:cNvSpPr txBox="1"/>
          <p:nvPr/>
        </p:nvSpPr>
        <p:spPr>
          <a:xfrm>
            <a:off x="6946738" y="893366"/>
            <a:ext cx="680123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Helvetica" pitchFamily="2" charset="0"/>
              </a:rPr>
              <a:t>DA (+)</a:t>
            </a:r>
            <a:endParaRPr lang="ja-JP" altLang="en-US" sz="1350">
              <a:latin typeface="Helvetica" pitchFamily="2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="" xmlns:a16="http://schemas.microsoft.com/office/drawing/2014/main" id="{4D3B5D43-D58E-824E-9A29-9DDF867A7EAC}"/>
              </a:ext>
            </a:extLst>
          </p:cNvPr>
          <p:cNvSpPr txBox="1"/>
          <p:nvPr/>
        </p:nvSpPr>
        <p:spPr>
          <a:xfrm>
            <a:off x="4659095" y="893366"/>
            <a:ext cx="636841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Helvetica" pitchFamily="2" charset="0"/>
              </a:rPr>
              <a:t>DA (-)</a:t>
            </a:r>
            <a:endParaRPr lang="ja-JP" altLang="en-US" sz="1350">
              <a:latin typeface="Helvetica" pitchFamily="2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="" xmlns:a16="http://schemas.microsoft.com/office/drawing/2014/main" id="{ED97B400-2FCB-A341-B1D9-2A6229CD2DC9}"/>
              </a:ext>
            </a:extLst>
          </p:cNvPr>
          <p:cNvSpPr txBox="1"/>
          <p:nvPr/>
        </p:nvSpPr>
        <p:spPr>
          <a:xfrm>
            <a:off x="6946738" y="3939989"/>
            <a:ext cx="680123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Helvetica" pitchFamily="2" charset="0"/>
              </a:rPr>
              <a:t>DA (+)</a:t>
            </a:r>
            <a:endParaRPr lang="ja-JP" altLang="en-US" sz="1350">
              <a:latin typeface="Helvetica" pitchFamily="2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="" xmlns:a16="http://schemas.microsoft.com/office/drawing/2014/main" id="{04C1DB69-3726-764F-ADBD-3C17CFCCD550}"/>
              </a:ext>
            </a:extLst>
          </p:cNvPr>
          <p:cNvSpPr txBox="1"/>
          <p:nvPr/>
        </p:nvSpPr>
        <p:spPr>
          <a:xfrm>
            <a:off x="4659095" y="3939989"/>
            <a:ext cx="636841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Helvetica" pitchFamily="2" charset="0"/>
              </a:rPr>
              <a:t>DA (-)</a:t>
            </a:r>
            <a:endParaRPr lang="ja-JP" altLang="en-US" sz="1350">
              <a:latin typeface="Helvetica" pitchFamily="2" charset="0"/>
            </a:endParaRPr>
          </a:p>
        </p:txBody>
      </p:sp>
      <p:pic>
        <p:nvPicPr>
          <p:cNvPr id="25" name="図 24">
            <a:extLst>
              <a:ext uri="{FF2B5EF4-FFF2-40B4-BE49-F238E27FC236}">
                <a16:creationId xmlns="" xmlns:a16="http://schemas.microsoft.com/office/drawing/2014/main" id="{2743A369-DD40-774D-8DC4-B3A6BF46FDD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31859" y="4298604"/>
            <a:ext cx="2035544" cy="1948238"/>
          </a:xfrm>
          <a:prstGeom prst="rect">
            <a:avLst/>
          </a:prstGeom>
        </p:spPr>
      </p:pic>
      <p:pic>
        <p:nvPicPr>
          <p:cNvPr id="29" name="図 28">
            <a:extLst>
              <a:ext uri="{FF2B5EF4-FFF2-40B4-BE49-F238E27FC236}">
                <a16:creationId xmlns="" xmlns:a16="http://schemas.microsoft.com/office/drawing/2014/main" id="{981014CE-D954-1B40-B524-2F246D2F37A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731860" y="1196594"/>
            <a:ext cx="2036437" cy="195030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="" xmlns:a16="http://schemas.microsoft.com/office/drawing/2014/main" id="{65454A9C-BE56-3742-813A-B9A2B08EA29B}"/>
              </a:ext>
            </a:extLst>
          </p:cNvPr>
          <p:cNvSpPr txBox="1"/>
          <p:nvPr/>
        </p:nvSpPr>
        <p:spPr>
          <a:xfrm>
            <a:off x="76200" y="26532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Supplemental Figure 1</a:t>
            </a:r>
            <a:endParaRPr kumimoji="1" lang="ja-JP" altLang="en-US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96622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図 11">
            <a:extLst>
              <a:ext uri="{FF2B5EF4-FFF2-40B4-BE49-F238E27FC236}">
                <a16:creationId xmlns="" xmlns:a16="http://schemas.microsoft.com/office/drawing/2014/main" id="{19C8C0D4-F87A-F549-B030-4D8AFDF9C4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42485" y="4298603"/>
            <a:ext cx="2022307" cy="1947638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="" xmlns:a16="http://schemas.microsoft.com/office/drawing/2014/main" id="{BCAB9B23-0652-3845-AD44-F7BFE651445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86682" y="1243863"/>
            <a:ext cx="2049869" cy="1916875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="" xmlns:a16="http://schemas.microsoft.com/office/drawing/2014/main" id="{2131B2EF-18AC-814C-BD86-AFAA4F3DB9B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06739" y="4287764"/>
            <a:ext cx="2060664" cy="1959078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="" xmlns:a16="http://schemas.microsoft.com/office/drawing/2014/main" id="{7FAC0F20-CB49-5545-9400-EE6FFEB6648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06739" y="1193448"/>
            <a:ext cx="2049869" cy="1937450"/>
          </a:xfrm>
          <a:prstGeom prst="rect">
            <a:avLst/>
          </a:prstGeom>
        </p:spPr>
      </p:pic>
      <p:pic>
        <p:nvPicPr>
          <p:cNvPr id="29" name="図 28">
            <a:extLst>
              <a:ext uri="{FF2B5EF4-FFF2-40B4-BE49-F238E27FC236}">
                <a16:creationId xmlns="" xmlns:a16="http://schemas.microsoft.com/office/drawing/2014/main" id="{64D0554A-9A17-374E-B2A4-E9EEE263683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40591" y="2171744"/>
            <a:ext cx="2227426" cy="2100798"/>
          </a:xfrm>
          <a:prstGeom prst="rect">
            <a:avLst/>
          </a:prstGeom>
        </p:spPr>
      </p:pic>
      <p:sp>
        <p:nvSpPr>
          <p:cNvPr id="16" name="テキスト ボックス 15">
            <a:extLst>
              <a:ext uri="{FF2B5EF4-FFF2-40B4-BE49-F238E27FC236}">
                <a16:creationId xmlns="" xmlns:a16="http://schemas.microsoft.com/office/drawing/2014/main" id="{A42BA02A-1713-6B48-836C-7A98E2834A5B}"/>
              </a:ext>
            </a:extLst>
          </p:cNvPr>
          <p:cNvSpPr txBox="1"/>
          <p:nvPr/>
        </p:nvSpPr>
        <p:spPr>
          <a:xfrm>
            <a:off x="746860" y="1688960"/>
            <a:ext cx="1631539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 smtClean="0">
                <a:latin typeface="Helvetica" pitchFamily="2" charset="0"/>
              </a:rPr>
              <a:t>Lymphocyte </a:t>
            </a:r>
            <a:r>
              <a:rPr lang="en-US" altLang="ja-JP" sz="1350" dirty="0">
                <a:latin typeface="Helvetica" pitchFamily="2" charset="0"/>
              </a:rPr>
              <a:t>gating</a:t>
            </a:r>
            <a:endParaRPr lang="ja-JP" altLang="en-US" sz="1350" dirty="0">
              <a:latin typeface="Helvetica" pitchFamily="2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="" xmlns:a16="http://schemas.microsoft.com/office/drawing/2014/main" id="{D7E21819-281D-FB4F-A915-731088146CC9}"/>
              </a:ext>
            </a:extLst>
          </p:cNvPr>
          <p:cNvSpPr txBox="1"/>
          <p:nvPr/>
        </p:nvSpPr>
        <p:spPr>
          <a:xfrm>
            <a:off x="193511" y="504724"/>
            <a:ext cx="61433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Helvetica" pitchFamily="2" charset="0"/>
              </a:rPr>
              <a:t>NALT</a:t>
            </a:r>
            <a:endParaRPr lang="ja-JP" altLang="en-US" sz="1350">
              <a:latin typeface="Helvetica" pitchFamily="2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="" xmlns:a16="http://schemas.microsoft.com/office/drawing/2014/main" id="{813BDD7E-A1AC-F04F-8D60-751C569EBF08}"/>
              </a:ext>
            </a:extLst>
          </p:cNvPr>
          <p:cNvSpPr txBox="1"/>
          <p:nvPr/>
        </p:nvSpPr>
        <p:spPr>
          <a:xfrm>
            <a:off x="5627949" y="587086"/>
            <a:ext cx="81976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 smtClean="0">
                <a:latin typeface="Helvetica" pitchFamily="2" charset="0"/>
              </a:rPr>
              <a:t>8 weeks</a:t>
            </a:r>
            <a:endParaRPr lang="ja-JP" altLang="en-US" sz="1350" dirty="0">
              <a:latin typeface="Helvetica" pitchFamily="2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="" xmlns:a16="http://schemas.microsoft.com/office/drawing/2014/main" id="{3D9771B7-FC4B-9943-8844-CB7B9061B7C4}"/>
              </a:ext>
            </a:extLst>
          </p:cNvPr>
          <p:cNvSpPr txBox="1"/>
          <p:nvPr/>
        </p:nvSpPr>
        <p:spPr>
          <a:xfrm>
            <a:off x="5579859" y="3714877"/>
            <a:ext cx="916049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 smtClean="0">
                <a:latin typeface="Helvetica" pitchFamily="2" charset="0"/>
              </a:rPr>
              <a:t>48 weeks</a:t>
            </a:r>
            <a:endParaRPr lang="ja-JP" altLang="en-US" sz="1350" dirty="0">
              <a:latin typeface="Helvetica" pitchFamily="2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="" xmlns:a16="http://schemas.microsoft.com/office/drawing/2014/main" id="{87FB549C-2F54-5E40-86D3-8A889BA9B878}"/>
              </a:ext>
            </a:extLst>
          </p:cNvPr>
          <p:cNvSpPr txBox="1"/>
          <p:nvPr/>
        </p:nvSpPr>
        <p:spPr>
          <a:xfrm>
            <a:off x="6946738" y="893366"/>
            <a:ext cx="680123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Helvetica" pitchFamily="2" charset="0"/>
              </a:rPr>
              <a:t>DA (+)</a:t>
            </a:r>
            <a:endParaRPr lang="ja-JP" altLang="en-US" sz="1350">
              <a:latin typeface="Helvetica" pitchFamily="2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="" xmlns:a16="http://schemas.microsoft.com/office/drawing/2014/main" id="{BBA70654-AFD7-7248-A123-7DD768F994BD}"/>
              </a:ext>
            </a:extLst>
          </p:cNvPr>
          <p:cNvSpPr txBox="1"/>
          <p:nvPr/>
        </p:nvSpPr>
        <p:spPr>
          <a:xfrm>
            <a:off x="4659095" y="893366"/>
            <a:ext cx="636841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Helvetica" pitchFamily="2" charset="0"/>
              </a:rPr>
              <a:t>DA (-)</a:t>
            </a:r>
            <a:endParaRPr lang="ja-JP" altLang="en-US" sz="1350">
              <a:latin typeface="Helvetica" pitchFamily="2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="" xmlns:a16="http://schemas.microsoft.com/office/drawing/2014/main" id="{809128E4-670E-5B49-804E-31BA6C52ECE4}"/>
              </a:ext>
            </a:extLst>
          </p:cNvPr>
          <p:cNvSpPr txBox="1"/>
          <p:nvPr/>
        </p:nvSpPr>
        <p:spPr>
          <a:xfrm>
            <a:off x="6946738" y="3939989"/>
            <a:ext cx="680123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Helvetica" pitchFamily="2" charset="0"/>
              </a:rPr>
              <a:t>DA (+)</a:t>
            </a:r>
            <a:endParaRPr lang="ja-JP" altLang="en-US" sz="1350">
              <a:latin typeface="Helvetica" pitchFamily="2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="" xmlns:a16="http://schemas.microsoft.com/office/drawing/2014/main" id="{712E7114-6486-284D-8E1E-EC554E7692D2}"/>
              </a:ext>
            </a:extLst>
          </p:cNvPr>
          <p:cNvSpPr txBox="1"/>
          <p:nvPr/>
        </p:nvSpPr>
        <p:spPr>
          <a:xfrm>
            <a:off x="4659095" y="3939989"/>
            <a:ext cx="636841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Helvetica" pitchFamily="2" charset="0"/>
              </a:rPr>
              <a:t>DA (-)</a:t>
            </a:r>
            <a:endParaRPr lang="ja-JP" altLang="en-US" sz="1350">
              <a:latin typeface="Helvetica" pitchFamily="2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="" xmlns:a16="http://schemas.microsoft.com/office/drawing/2014/main" id="{36576DEB-3557-1B4F-BC76-F264139EB090}"/>
              </a:ext>
            </a:extLst>
          </p:cNvPr>
          <p:cNvSpPr txBox="1"/>
          <p:nvPr/>
        </p:nvSpPr>
        <p:spPr>
          <a:xfrm>
            <a:off x="76200" y="26532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Supplemental Figure 1</a:t>
            </a:r>
            <a:endParaRPr kumimoji="1" lang="ja-JP" altLang="en-US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5166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2</TotalTime>
  <Words>47</Words>
  <Application>Microsoft Office PowerPoint</Application>
  <PresentationFormat>On-screen Show (4:3)</PresentationFormat>
  <Paragraphs>20</Paragraphs>
  <Slides>2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テーマ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FORTE   M.Tsunoda</cp:lastModifiedBy>
  <cp:revision>8</cp:revision>
  <dcterms:created xsi:type="dcterms:W3CDTF">2019-06-30T09:26:28Z</dcterms:created>
  <dcterms:modified xsi:type="dcterms:W3CDTF">2019-07-08T01:49:28Z</dcterms:modified>
</cp:coreProperties>
</file>